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1.png" ContentType="image/png"/>
  <Override PartName="/ppt/media/image6.wmf" ContentType="image/x-wmf"/>
  <Override PartName="/ppt/media/image14.wmf" ContentType="image/x-wmf"/>
  <Override PartName="/ppt/media/image9.wmf" ContentType="image/x-wmf"/>
  <Override PartName="/ppt/media/image15.wmf" ContentType="image/x-wmf"/>
  <Override PartName="/ppt/media/image1.jpeg" ContentType="image/jpeg"/>
  <Override PartName="/ppt/media/image3.png" ContentType="image/png"/>
  <Override PartName="/ppt/media/image7.wmf" ContentType="image/x-wmf"/>
  <Override PartName="/ppt/media/image12.wmf" ContentType="image/x-wmf"/>
  <Override PartName="/ppt/media/image4.png" ContentType="image/png"/>
  <Override PartName="/ppt/media/image8.wmf" ContentType="image/x-wmf"/>
  <Override PartName="/ppt/media/image5.png" ContentType="image/png"/>
  <Override PartName="/ppt/media/image13.wmf" ContentType="image/x-wmf"/>
  <Override PartName="/ppt/media/image2.png" ContentType="image/png"/>
  <Override PartName="/ppt/media/image10.wmf" ContentType="image/x-wmf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F38FFF-F167-496B-B6B0-77A7F0FCEC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FF4935-F088-4AFC-8849-6EC0545D9A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7E879F-EC08-455A-A12E-1B4B261A348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2DA27F-0F50-44D3-BDE6-99CF175A87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387595-6CEA-49F5-BEA0-515CB347A1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5C2F60-F664-43CE-AF8A-864B2F29E9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A784BA-011A-4CF2-9240-6AC529FB74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256FD-FCAF-458C-BE05-91A43AFF00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50DE80-9AB6-46A3-A748-C8A72B2CE5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87FBDC-BDCA-461A-B0AF-882EDB3F1F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370FF4-68A8-4169-9857-127566E309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C4660D-7815-4DDB-A09A-4D7F221007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C8231E-4DE3-4A00-A41E-FA955AFB4845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image" Target="../media/image7.wmf"/><Relationship Id="rId3" Type="http://schemas.openxmlformats.org/officeDocument/2006/relationships/image" Target="../media/image8.wmf"/><Relationship Id="rId4" Type="http://schemas.openxmlformats.org/officeDocument/2006/relationships/image" Target="../media/image9.wmf"/><Relationship Id="rId5" Type="http://schemas.openxmlformats.org/officeDocument/2006/relationships/image" Target="../media/image10.wmf"/><Relationship Id="rId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2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3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4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15.wmf"/><Relationship Id="rId9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438280" y="304920"/>
            <a:ext cx="205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457200" y="6276240"/>
            <a:ext cx="617220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Figure S1. 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Phylogenetic tree of LexA binding sites in cyanobacteria, 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B.subtilis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0" lang="zh-CN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-proteobacteria and 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E.coli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. Binding sites of cyanobacteria were predicted in this study, those of 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B.subtilis 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were from DBTBS [1], those of </a:t>
            </a:r>
            <a:r>
              <a:rPr b="0" lang="zh-CN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-proteobacteria were taken from Erill et al [2], and those of 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E.coli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were from RegulonDB [3]. Phylogenetic tree was constructed by the STAMP[4] web tool, sequence logos were generated by weblogo [5].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609480" y="2220840"/>
            <a:ext cx="5484960" cy="3129120"/>
            <a:chOff x="609480" y="2220840"/>
            <a:chExt cx="5484960" cy="3129120"/>
          </a:xfrm>
        </p:grpSpPr>
        <p:pic>
          <p:nvPicPr>
            <p:cNvPr id="44" name="" descr=""/>
            <p:cNvPicPr/>
            <p:nvPr/>
          </p:nvPicPr>
          <p:blipFill>
            <a:blip r:embed="rId1"/>
            <a:stretch/>
          </p:blipFill>
          <p:spPr>
            <a:xfrm>
              <a:off x="609480" y="2362320"/>
              <a:ext cx="3300480" cy="260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2"/>
            <a:stretch/>
          </p:blipFill>
          <p:spPr>
            <a:xfrm>
              <a:off x="4038480" y="2984400"/>
              <a:ext cx="2032200" cy="68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" descr=""/>
            <p:cNvPicPr/>
            <p:nvPr/>
          </p:nvPicPr>
          <p:blipFill>
            <a:blip r:embed="rId3"/>
            <a:stretch/>
          </p:blipFill>
          <p:spPr>
            <a:xfrm>
              <a:off x="4029120" y="3808440"/>
              <a:ext cx="2031840" cy="68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" descr=""/>
            <p:cNvPicPr/>
            <p:nvPr/>
          </p:nvPicPr>
          <p:blipFill>
            <a:blip r:embed="rId4"/>
            <a:stretch/>
          </p:blipFill>
          <p:spPr>
            <a:xfrm>
              <a:off x="4022640" y="4610160"/>
              <a:ext cx="2071800" cy="739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" descr=""/>
            <p:cNvPicPr/>
            <p:nvPr/>
          </p:nvPicPr>
          <p:blipFill>
            <a:blip r:embed="rId5"/>
            <a:stretch/>
          </p:blipFill>
          <p:spPr>
            <a:xfrm>
              <a:off x="4019400" y="2220840"/>
              <a:ext cx="2019600" cy="7066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3672000" y="3286080"/>
            <a:ext cx="2759040" cy="219564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2"/>
          <a:stretch/>
        </p:blipFill>
        <p:spPr>
          <a:xfrm>
            <a:off x="754200" y="3301920"/>
            <a:ext cx="2732040" cy="219888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3"/>
          <a:stretch/>
        </p:blipFill>
        <p:spPr>
          <a:xfrm>
            <a:off x="711360" y="5586480"/>
            <a:ext cx="2754000" cy="215424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4"/>
          <a:stretch/>
        </p:blipFill>
        <p:spPr>
          <a:xfrm>
            <a:off x="3665520" y="987480"/>
            <a:ext cx="2798640" cy="218736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5"/>
          <a:stretch/>
        </p:blipFill>
        <p:spPr>
          <a:xfrm>
            <a:off x="774720" y="1014480"/>
            <a:ext cx="2793960" cy="218592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847800" y="838080"/>
            <a:ext cx="2895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zh-CN" sz="900" spc="-1" strike="noStrike">
                <a:solidFill>
                  <a:srgbClr val="000000"/>
                </a:solidFill>
                <a:latin typeface="Arial"/>
              </a:rPr>
              <a:t>Synechococcus sp. </a:t>
            </a:r>
            <a:r>
              <a:rPr b="1" lang="zh-CN" sz="900" spc="-1" strike="noStrike">
                <a:solidFill>
                  <a:srgbClr val="000000"/>
                </a:solidFill>
                <a:latin typeface="Arial"/>
              </a:rPr>
              <a:t>JA-3-3Ab A-Prim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400480" y="152280"/>
            <a:ext cx="205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923760" y="5524560"/>
            <a:ext cx="3095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Synechococcus_elongatus_PCC_630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828720" y="3209760"/>
            <a:ext cx="3124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</a:rPr>
              <a:t>Thermosynechococcus_elongatus BP-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rot="16200000">
            <a:off x="-360720" y="4244400"/>
            <a:ext cx="163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robability or LO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676520" y="7772400"/>
            <a:ext cx="83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cor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914400" y="8229600"/>
            <a:ext cx="5410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Results of genome-wide scanning for LexA-like binding sites in the five genomes that do not encode a LexA protei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895560" y="3228840"/>
            <a:ext cx="2590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Trichodesmium_erythraeum_IMS10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648320" y="5486400"/>
            <a:ext cx="83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cor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"/>
          <p:cNvGrpSpPr/>
          <p:nvPr/>
        </p:nvGrpSpPr>
        <p:grpSpPr>
          <a:xfrm>
            <a:off x="4419720" y="6172200"/>
            <a:ext cx="2438280" cy="1222560"/>
            <a:chOff x="4419720" y="6172200"/>
            <a:chExt cx="2438280" cy="1222560"/>
          </a:xfrm>
        </p:grpSpPr>
        <p:sp>
          <p:nvSpPr>
            <p:cNvPr id="64" name=""/>
            <p:cNvSpPr/>
            <p:nvPr/>
          </p:nvSpPr>
          <p:spPr>
            <a:xfrm>
              <a:off x="4419720" y="6361200"/>
              <a:ext cx="345960" cy="0"/>
            </a:xfrm>
            <a:prstGeom prst="line">
              <a:avLst/>
            </a:prstGeom>
            <a:ln w="1908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419720" y="6578640"/>
              <a:ext cx="345960" cy="0"/>
            </a:xfrm>
            <a:prstGeom prst="line">
              <a:avLst/>
            </a:prstGeom>
            <a:ln w="190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419720" y="6807240"/>
              <a:ext cx="34596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4765680" y="6172200"/>
              <a:ext cx="208116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zh-CN" sz="10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r>
                <a:rPr b="1" lang="zh-CN" sz="1000" spc="-1" strike="noStrike">
                  <a:solidFill>
                    <a:srgbClr val="000000"/>
                  </a:solidFill>
                  <a:latin typeface="Arial"/>
                </a:rPr>
                <a:t>(S</a:t>
              </a:r>
              <a:r>
                <a:rPr b="1" lang="zh-CN" sz="1000" spc="-1" strike="noStrike" baseline="-25000">
                  <a:solidFill>
                    <a:srgbClr val="000000"/>
                  </a:solidFill>
                  <a:latin typeface="Arial"/>
                </a:rPr>
                <a:t>Iu</a:t>
              </a:r>
              <a:r>
                <a:rPr b="1" lang="zh-CN" sz="1000" spc="-1" strike="noStrike">
                  <a:solidFill>
                    <a:srgbClr val="000000"/>
                  </a:solidFill>
                  <a:latin typeface="Arial"/>
                </a:rPr>
                <a:t> &gt; </a:t>
              </a:r>
              <a:r>
                <a:rPr b="1" i="1" lang="zh-CN" sz="1000" spc="-1" strike="noStrike">
                  <a:solidFill>
                    <a:srgbClr val="000000"/>
                  </a:solidFill>
                  <a:latin typeface="Arial"/>
                </a:rPr>
                <a:t>s</a:t>
              </a:r>
              <a:r>
                <a:rPr b="1" lang="zh-CN" sz="1000" spc="-1" strike="noStrike">
                  <a:solidFill>
                    <a:srgbClr val="000000"/>
                  </a:solidFill>
                  <a:latin typeface="Arial"/>
                </a:rPr>
                <a:t>)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4765680" y="6402240"/>
              <a:ext cx="208116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zh-CN" sz="10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r>
                <a:rPr b="1" lang="zh-CN" sz="1000" spc="-1" strike="noStrike">
                  <a:solidFill>
                    <a:srgbClr val="000000"/>
                  </a:solidFill>
                  <a:latin typeface="Arial"/>
                </a:rPr>
                <a:t>(S</a:t>
              </a:r>
              <a:r>
                <a:rPr b="1" lang="zh-CN" sz="1000" spc="-1" strike="noStrike" baseline="-25000">
                  <a:solidFill>
                    <a:srgbClr val="000000"/>
                  </a:solidFill>
                  <a:latin typeface="Arial"/>
                </a:rPr>
                <a:t>Cu</a:t>
              </a:r>
              <a:r>
                <a:rPr b="1" lang="zh-CN" sz="1000" spc="-1" strike="noStrike">
                  <a:solidFill>
                    <a:srgbClr val="000000"/>
                  </a:solidFill>
                  <a:latin typeface="Arial"/>
                </a:rPr>
                <a:t> &gt; </a:t>
              </a:r>
              <a:r>
                <a:rPr b="1" i="1" lang="zh-CN" sz="1000" spc="-1" strike="noStrike">
                  <a:solidFill>
                    <a:srgbClr val="000000"/>
                  </a:solidFill>
                  <a:latin typeface="Arial"/>
                </a:rPr>
                <a:t>s</a:t>
              </a:r>
              <a:r>
                <a:rPr b="1" lang="zh-CN" sz="1000" spc="-1" strike="noStrike">
                  <a:solidFill>
                    <a:srgbClr val="000000"/>
                  </a:solidFill>
                  <a:latin typeface="Arial"/>
                </a:rPr>
                <a:t>)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776840" y="6643800"/>
              <a:ext cx="208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zh-CN" sz="1000" spc="-1" strike="noStrike">
                  <a:solidFill>
                    <a:srgbClr val="000000"/>
                  </a:solidFill>
                  <a:latin typeface="Arial"/>
                </a:rPr>
                <a:t>LOR</a:t>
              </a:r>
              <a:r>
                <a:rPr b="1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4430880" y="6981840"/>
              <a:ext cx="345960" cy="0"/>
            </a:xfrm>
            <a:prstGeom prst="line">
              <a:avLst/>
            </a:prstGeom>
            <a:ln w="190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4765680" y="6850080"/>
              <a:ext cx="2081160" cy="54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zh-CN" sz="10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r>
                <a:rPr b="1" lang="zh-CN" sz="1000" spc="-1" strike="noStrike">
                  <a:solidFill>
                    <a:srgbClr val="000000"/>
                  </a:solidFill>
                  <a:latin typeface="Arial"/>
                </a:rPr>
                <a:t>(S</a:t>
              </a:r>
              <a:r>
                <a:rPr b="1" lang="zh-CN" sz="1400" spc="-1" strike="noStrike" baseline="-25000">
                  <a:solidFill>
                    <a:srgbClr val="000000"/>
                  </a:solidFill>
                  <a:latin typeface="Arial"/>
                </a:rPr>
                <a:t>Iu</a:t>
              </a:r>
              <a:r>
                <a:rPr b="1" lang="zh-CN" sz="1000" spc="-1" strike="noStrike">
                  <a:solidFill>
                    <a:srgbClr val="000000"/>
                  </a:solidFill>
                  <a:latin typeface="Arial"/>
                </a:rPr>
                <a:t> &gt; </a:t>
              </a:r>
              <a:r>
                <a:rPr b="1" i="1" lang="zh-CN" sz="1000" spc="-1" strike="noStrike">
                  <a:solidFill>
                    <a:srgbClr val="000000"/>
                  </a:solidFill>
                  <a:latin typeface="Arial"/>
                </a:rPr>
                <a:t>s</a:t>
              </a:r>
              <a:r>
                <a:rPr b="1" lang="zh-CN" sz="10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9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" name=""/>
          <p:cNvSpPr/>
          <p:nvPr/>
        </p:nvSpPr>
        <p:spPr>
          <a:xfrm rot="5400000">
            <a:off x="4973040" y="4366800"/>
            <a:ext cx="304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Number of predicted LexA box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657600" y="714240"/>
            <a:ext cx="2895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zh-CN" sz="900" spc="-1" strike="noStrike">
                <a:solidFill>
                  <a:srgbClr val="000000"/>
                </a:solidFill>
                <a:latin typeface="Arial"/>
              </a:rPr>
              <a:t>Synechococcus sp.</a:t>
            </a:r>
            <a:r>
              <a:rPr b="1" lang="zh-CN" sz="900" spc="-1" strike="noStrike">
                <a:solidFill>
                  <a:srgbClr val="000000"/>
                </a:solidFill>
                <a:latin typeface="Arial"/>
              </a:rPr>
              <a:t> JA-2-3B'a (2-13) B-Prime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" descr=""/>
          <p:cNvPicPr/>
          <p:nvPr/>
        </p:nvPicPr>
        <p:blipFill>
          <a:blip r:embed="rId1"/>
          <a:stretch/>
        </p:blipFill>
        <p:spPr>
          <a:xfrm>
            <a:off x="789120" y="44280"/>
            <a:ext cx="5040360" cy="9023400"/>
          </a:xfrm>
          <a:prstGeom prst="rect">
            <a:avLst/>
          </a:prstGeom>
          <a:ln w="0">
            <a:noFill/>
          </a:ln>
        </p:spPr>
      </p:pic>
      <p:sp>
        <p:nvSpPr>
          <p:cNvPr id="75" name=""/>
          <p:cNvSpPr/>
          <p:nvPr/>
        </p:nvSpPr>
        <p:spPr>
          <a:xfrm rot="5400000">
            <a:off x="5340600" y="4380480"/>
            <a:ext cx="205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igure S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230640" y="4140360"/>
            <a:ext cx="55440" cy="55440"/>
          </a:xfrm>
          <a:prstGeom prst="ellipse">
            <a:avLst/>
          </a:prstGeom>
          <a:solidFill>
            <a:srgbClr val="ff0000"/>
          </a:solidFill>
          <a:ln w="32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0" bIns="-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695160" y="4132440"/>
            <a:ext cx="55800" cy="55440"/>
          </a:xfrm>
          <a:prstGeom prst="ellipse">
            <a:avLst/>
          </a:prstGeom>
          <a:solidFill>
            <a:srgbClr val="ff0000"/>
          </a:solidFill>
          <a:ln w="32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0" bIns="-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695160" y="2133720"/>
            <a:ext cx="55800" cy="55440"/>
          </a:xfrm>
          <a:prstGeom prst="ellipse">
            <a:avLst/>
          </a:prstGeom>
          <a:solidFill>
            <a:srgbClr val="ff0000"/>
          </a:solidFill>
          <a:ln w="32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0" bIns="-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214800" y="2139840"/>
            <a:ext cx="55440" cy="55800"/>
          </a:xfrm>
          <a:prstGeom prst="ellipse">
            <a:avLst/>
          </a:prstGeom>
          <a:solidFill>
            <a:srgbClr val="ff0000"/>
          </a:solidFill>
          <a:ln w="32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840" bIns="-6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flipH="1">
            <a:off x="5790960" y="7696080"/>
            <a:ext cx="228600" cy="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3276720" y="7696080"/>
            <a:ext cx="228600" cy="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52280" y="6872040"/>
            <a:ext cx="32767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Figure S4. 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Multiple sequence alignments of the full-length LexA in the 27 cyanobacterial genomes. The sequence from 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E.coli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LexA is also included for comparison. The auto-cleavage sites are indicated by a red arrow, and the reactive residues are indicated by red dot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3" name=""/>
          <p:cNvGraphicFramePr/>
          <p:nvPr/>
        </p:nvGraphicFramePr>
        <p:xfrm>
          <a:off x="762120" y="5257800"/>
          <a:ext cx="5199120" cy="13604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8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62120" y="5257800"/>
                    <a:ext cx="5199120" cy="1360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5" name=""/>
          <p:cNvSpPr/>
          <p:nvPr/>
        </p:nvSpPr>
        <p:spPr>
          <a:xfrm>
            <a:off x="135000" y="1905120"/>
            <a:ext cx="366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22400" y="2971800"/>
            <a:ext cx="517320" cy="51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i="1" lang="en-US" sz="24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7" name=""/>
          <p:cNvGrpSpPr/>
          <p:nvPr/>
        </p:nvGrpSpPr>
        <p:grpSpPr>
          <a:xfrm>
            <a:off x="762120" y="1454040"/>
            <a:ext cx="4479840" cy="945360"/>
            <a:chOff x="762120" y="1454040"/>
            <a:chExt cx="4479840" cy="945360"/>
          </a:xfrm>
        </p:grpSpPr>
        <p:sp>
          <p:nvSpPr>
            <p:cNvPr id="88" name=""/>
            <p:cNvSpPr/>
            <p:nvPr/>
          </p:nvSpPr>
          <p:spPr>
            <a:xfrm flipV="1">
              <a:off x="762120" y="2117520"/>
              <a:ext cx="4479840" cy="56880"/>
            </a:xfrm>
            <a:prstGeom prst="rect">
              <a:avLst/>
            </a:prstGeom>
            <a:solidFill>
              <a:srgbClr val="ff33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080" bIns="100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351240" y="2035080"/>
              <a:ext cx="1809360" cy="222480"/>
            </a:xfrm>
            <a:custGeom>
              <a:avLst/>
              <a:gdLst>
                <a:gd name="textAreaLeft" fmla="*/ 0 w 1809360"/>
                <a:gd name="textAreaRight" fmla="*/ 1809720 w 1809360"/>
                <a:gd name="textAreaTop" fmla="*/ 0 h 222480"/>
                <a:gd name="textAreaBottom" fmla="*/ 222840 h 2224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00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785960" y="2035080"/>
              <a:ext cx="1328400" cy="219240"/>
            </a:xfrm>
            <a:custGeom>
              <a:avLst/>
              <a:gdLst>
                <a:gd name="textAreaLeft" fmla="*/ 0 w 1328400"/>
                <a:gd name="textAreaRight" fmla="*/ 1328760 w 1328400"/>
                <a:gd name="textAreaTop" fmla="*/ 0 h 219240"/>
                <a:gd name="textAreaBottom" fmla="*/ 219600 h 2192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00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122120" y="2035080"/>
              <a:ext cx="99720" cy="216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127240" y="1870200"/>
              <a:ext cx="477360" cy="510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24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r>
                <a:rPr b="0" i="1" lang="en-US" sz="2400" spc="-1" strike="noStrike" baseline="-25000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4136040" y="1889280"/>
              <a:ext cx="448920" cy="510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24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r>
                <a:rPr b="0" i="1" lang="en-US" sz="24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rot="5400000">
              <a:off x="1122120" y="1430280"/>
              <a:ext cx="174600" cy="894960"/>
            </a:xfrm>
            <a:custGeom>
              <a:avLst/>
              <a:gdLst>
                <a:gd name="textAreaLeft" fmla="*/ 111600 w 174600"/>
                <a:gd name="textAreaRight" fmla="*/ 174960 w 174600"/>
                <a:gd name="textAreaTop" fmla="*/ 23040 h 894960"/>
                <a:gd name="textAreaBottom" fmla="*/ 871920 h 89496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1156320" y="1454040"/>
              <a:ext cx="2660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24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6" name=""/>
          <p:cNvGrpSpPr/>
          <p:nvPr/>
        </p:nvGrpSpPr>
        <p:grpSpPr>
          <a:xfrm>
            <a:off x="701640" y="3171960"/>
            <a:ext cx="4647960" cy="217440"/>
            <a:chOff x="701640" y="3171960"/>
            <a:chExt cx="4647960" cy="217440"/>
          </a:xfrm>
        </p:grpSpPr>
        <p:sp>
          <p:nvSpPr>
            <p:cNvPr id="97" name=""/>
            <p:cNvSpPr/>
            <p:nvPr/>
          </p:nvSpPr>
          <p:spPr>
            <a:xfrm flipV="1">
              <a:off x="701640" y="3252960"/>
              <a:ext cx="4647960" cy="5688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080" bIns="100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390840" y="3171960"/>
              <a:ext cx="1874880" cy="217440"/>
            </a:xfrm>
            <a:custGeom>
              <a:avLst/>
              <a:gdLst>
                <a:gd name="textAreaLeft" fmla="*/ 0 w 1874880"/>
                <a:gd name="textAreaRight" fmla="*/ 1875240 w 1874880"/>
                <a:gd name="textAreaTop" fmla="*/ 0 h 217440"/>
                <a:gd name="textAreaBottom" fmla="*/ 217800 h 2174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00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815840" y="3171960"/>
              <a:ext cx="1378080" cy="215640"/>
            </a:xfrm>
            <a:custGeom>
              <a:avLst/>
              <a:gdLst>
                <a:gd name="textAreaLeft" fmla="*/ 0 w 1378080"/>
                <a:gd name="textAreaRight" fmla="*/ 1378440 w 1378080"/>
                <a:gd name="textAreaTop" fmla="*/ 0 h 215640"/>
                <a:gd name="textAreaBottom" fmla="*/ 216000 h 215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00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1170000" y="3171960"/>
              <a:ext cx="104760" cy="212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1" name=""/>
          <p:cNvSpPr/>
          <p:nvPr/>
        </p:nvSpPr>
        <p:spPr>
          <a:xfrm>
            <a:off x="2189880" y="2981160"/>
            <a:ext cx="448920" cy="51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i="1" lang="en-US" sz="24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4226760" y="2981160"/>
            <a:ext cx="448920" cy="51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i="1" lang="en-US" sz="2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417960" y="2438280"/>
            <a:ext cx="1918440" cy="52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0" i="1" lang="en-US" sz="2400" spc="-1" strike="noStrike" baseline="-30000">
                <a:solidFill>
                  <a:srgbClr val="000000"/>
                </a:solidFill>
                <a:latin typeface="Arial"/>
              </a:rPr>
              <a:t>1</a:t>
            </a: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(g</a:t>
            </a:r>
            <a:r>
              <a:rPr b="0" i="1" lang="en-US" sz="2400" spc="-1" strike="noStrike" baseline="-30000">
                <a:solidFill>
                  <a:srgbClr val="000000"/>
                </a:solidFill>
                <a:latin typeface="Arial"/>
              </a:rPr>
              <a:t>1</a:t>
            </a: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), o</a:t>
            </a:r>
            <a:r>
              <a:rPr b="0" i="1" lang="en-US" sz="2400" spc="-1" strike="noStrike" baseline="-30000">
                <a:solidFill>
                  <a:srgbClr val="000000"/>
                </a:solidFill>
                <a:latin typeface="Arial"/>
              </a:rPr>
              <a:t>1</a:t>
            </a: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(g</a:t>
            </a:r>
            <a:r>
              <a:rPr b="0" i="1" lang="en-US" sz="2400" spc="-1" strike="noStrike" baseline="-30000">
                <a:solidFill>
                  <a:srgbClr val="000000"/>
                </a:solidFill>
                <a:latin typeface="Arial"/>
              </a:rPr>
              <a:t>2</a:t>
            </a: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)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rot="5400000">
            <a:off x="1168200" y="2505240"/>
            <a:ext cx="174600" cy="895320"/>
          </a:xfrm>
          <a:custGeom>
            <a:avLst/>
            <a:gdLst>
              <a:gd name="textAreaLeft" fmla="*/ 111600 w 174600"/>
              <a:gd name="textAreaRight" fmla="*/ 174960 w 174600"/>
              <a:gd name="textAreaTop" fmla="*/ 23040 h 895320"/>
              <a:gd name="textAreaBottom" fmla="*/ 872280 h 8953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 flipV="1">
            <a:off x="533520" y="4418640"/>
            <a:ext cx="5829120" cy="58680"/>
          </a:xfrm>
          <a:prstGeom prst="rect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1880" bIns="11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4648320" y="4343400"/>
            <a:ext cx="1809720" cy="233280"/>
          </a:xfrm>
          <a:custGeom>
            <a:avLst/>
            <a:gdLst>
              <a:gd name="textAreaLeft" fmla="*/ 0 w 1809720"/>
              <a:gd name="textAreaRight" fmla="*/ 1810080 w 1809720"/>
              <a:gd name="textAreaTop" fmla="*/ 0 h 233280"/>
              <a:gd name="textAreaBottom" fmla="*/ 233640 h 233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1676520" y="4343400"/>
            <a:ext cx="1328760" cy="231840"/>
          </a:xfrm>
          <a:custGeom>
            <a:avLst/>
            <a:gdLst>
              <a:gd name="textAreaLeft" fmla="*/ 0 w 1328760"/>
              <a:gd name="textAreaRight" fmla="*/ 1329120 w 1328760"/>
              <a:gd name="textAreaTop" fmla="*/ 0 h 231840"/>
              <a:gd name="textAreaBottom" fmla="*/ 232200 h 2318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1268280" y="4334040"/>
            <a:ext cx="100080" cy="226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886200" y="4343400"/>
            <a:ext cx="100080" cy="227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112680" y="4249800"/>
            <a:ext cx="517320" cy="51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i="1" lang="en-US" sz="2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rot="5400000">
            <a:off x="1045080" y="3807720"/>
            <a:ext cx="176040" cy="895320"/>
          </a:xfrm>
          <a:custGeom>
            <a:avLst/>
            <a:gdLst>
              <a:gd name="textAreaLeft" fmla="*/ 112680 w 176040"/>
              <a:gd name="textAreaRight" fmla="*/ 176400 w 176040"/>
              <a:gd name="textAreaTop" fmla="*/ 23040 h 895320"/>
              <a:gd name="textAreaBottom" fmla="*/ 872280 h 8953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776880" y="3619440"/>
            <a:ext cx="1006920" cy="52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0" i="1" lang="en-US" sz="2400" spc="-1" strike="noStrike" baseline="-30000">
                <a:solidFill>
                  <a:srgbClr val="000000"/>
                </a:solidFill>
                <a:latin typeface="Arial"/>
              </a:rPr>
              <a:t>2</a:t>
            </a: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(g</a:t>
            </a:r>
            <a:r>
              <a:rPr b="0" i="1" lang="en-US" sz="2400" spc="-1" strike="noStrike" baseline="-30000">
                <a:solidFill>
                  <a:srgbClr val="000000"/>
                </a:solidFill>
                <a:latin typeface="Arial"/>
              </a:rPr>
              <a:t>1</a:t>
            </a: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)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005640" y="3657600"/>
            <a:ext cx="1006920" cy="52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0" i="1" lang="en-US" sz="2400" spc="-1" strike="noStrike" baseline="-30000">
                <a:solidFill>
                  <a:srgbClr val="000000"/>
                </a:solidFill>
                <a:latin typeface="Arial"/>
              </a:rPr>
              <a:t>2</a:t>
            </a: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(g</a:t>
            </a:r>
            <a:r>
              <a:rPr b="0" i="1" lang="en-US" sz="2400" spc="-1" strike="noStrike" baseline="-30000">
                <a:solidFill>
                  <a:srgbClr val="000000"/>
                </a:solidFill>
                <a:latin typeface="Arial"/>
              </a:rPr>
              <a:t>2</a:t>
            </a: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)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 rot="5400000">
            <a:off x="3679560" y="3558960"/>
            <a:ext cx="176040" cy="1287720"/>
          </a:xfrm>
          <a:custGeom>
            <a:avLst/>
            <a:gdLst>
              <a:gd name="textAreaLeft" fmla="*/ 112680 w 176040"/>
              <a:gd name="textAreaRight" fmla="*/ 176400 w 176040"/>
              <a:gd name="textAreaTop" fmla="*/ 33480 h 1287720"/>
              <a:gd name="textAreaBottom" fmla="*/ 1254240 h 1287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2142360" y="4191120"/>
            <a:ext cx="448920" cy="51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i="1" lang="en-US" sz="24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5571360" y="4162320"/>
            <a:ext cx="448920" cy="51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i="1" lang="en-US" sz="2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2743200" y="228600"/>
            <a:ext cx="144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igure S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8" name=""/>
          <p:cNvGraphicFramePr/>
          <p:nvPr/>
        </p:nvGraphicFramePr>
        <p:xfrm>
          <a:off x="2325600" y="2743200"/>
          <a:ext cx="2208240" cy="3319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19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325600" y="2743200"/>
                    <a:ext cx="2208240" cy="331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0" name=""/>
          <p:cNvSpPr/>
          <p:nvPr/>
        </p:nvSpPr>
        <p:spPr>
          <a:xfrm>
            <a:off x="3276720" y="6172200"/>
            <a:ext cx="2743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000" spc="-1" strike="noStrike">
                <a:solidFill>
                  <a:srgbClr val="000000"/>
                </a:solidFill>
                <a:latin typeface="Arial"/>
              </a:rPr>
              <a:t>in this example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 flipH="1">
            <a:off x="1218960" y="1143000"/>
            <a:ext cx="1066680" cy="9144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209680" y="914400"/>
            <a:ext cx="3124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utative binding site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23" name=""/>
          <p:cNvGraphicFramePr/>
          <p:nvPr/>
        </p:nvGraphicFramePr>
        <p:xfrm>
          <a:off x="4191120" y="3733920"/>
          <a:ext cx="2244600" cy="3315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24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4191120" y="3733920"/>
                    <a:ext cx="2244600" cy="331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5" name=""/>
          <p:cNvSpPr/>
          <p:nvPr/>
        </p:nvSpPr>
        <p:spPr>
          <a:xfrm>
            <a:off x="593640" y="6894360"/>
            <a:ext cx="6607440" cy="133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For </a:t>
            </a:r>
            <a:r>
              <a:rPr b="0" i="1" lang="zh-CN" sz="18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0" i="1" lang="zh-CN" sz="18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i="1" lang="zh-CN" sz="1800" spc="-1" strike="noStrike">
                <a:solidFill>
                  <a:srgbClr val="000000"/>
                </a:solidFill>
                <a:latin typeface="Arial"/>
              </a:rPr>
              <a:t>(g</a:t>
            </a:r>
            <a:r>
              <a:rPr b="0" i="1" lang="zh-CN" sz="18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i="1" lang="zh-CN" sz="1800" spc="-1" strike="noStrike">
                <a:solidFill>
                  <a:srgbClr val="000000"/>
                </a:solidFill>
                <a:latin typeface="Arial"/>
              </a:rPr>
              <a:t>), o</a:t>
            </a:r>
            <a:r>
              <a:rPr b="0" i="1" lang="zh-CN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i="1" lang="zh-CN" sz="1800" spc="-1" strike="noStrike">
                <a:solidFill>
                  <a:srgbClr val="000000"/>
                </a:solidFill>
                <a:latin typeface="Arial"/>
              </a:rPr>
              <a:t>(g</a:t>
            </a:r>
            <a:r>
              <a:rPr b="0" i="1" lang="zh-CN" sz="18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i="1" lang="zh-CN" sz="1800" spc="-1" strike="noStrike">
                <a:solidFill>
                  <a:srgbClr val="000000"/>
                </a:solidFill>
                <a:latin typeface="Arial"/>
              </a:rPr>
              <a:t>) and o</a:t>
            </a:r>
            <a:r>
              <a:rPr b="0" i="1" lang="zh-CN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i="1" lang="zh-CN" sz="1800" spc="-1" strike="noStrike">
                <a:solidFill>
                  <a:srgbClr val="000000"/>
                </a:solidFill>
                <a:latin typeface="Arial"/>
              </a:rPr>
              <a:t>(g</a:t>
            </a:r>
            <a:r>
              <a:rPr b="0" i="1" lang="zh-CN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i="1" lang="zh-CN" sz="1800" spc="-1" strike="noStrike">
                <a:solidFill>
                  <a:srgbClr val="000000"/>
                </a:solidFill>
                <a:latin typeface="Arial"/>
              </a:rPr>
              <a:t>),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ssume they have the sam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value of sequence similarity to </a:t>
            </a:r>
            <a:r>
              <a:rPr b="0" i="1" lang="zh-CN" sz="20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0" i="1" lang="zh-CN" sz="1800" spc="-1" strike="noStrike">
                <a:solidFill>
                  <a:srgbClr val="000000"/>
                </a:solidFill>
                <a:latin typeface="Arial"/>
              </a:rPr>
              <a:t>,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i.e.,                 . Then w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hould select orthologs of g</a:t>
            </a:r>
            <a:r>
              <a:rPr b="0" lang="zh-CN" sz="18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in this case, i.e., i =1, and ad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its average score across genome </a:t>
            </a:r>
            <a:r>
              <a:rPr b="0" i="1" lang="zh-CN" sz="18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i="1" lang="zh-CN" sz="18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lang="zh-CN" sz="1800" spc="-1" strike="noStrike" baseline="-25000">
                <a:solidFill>
                  <a:srgbClr val="000000"/>
                </a:solidFill>
                <a:latin typeface="Arial"/>
              </a:rPr>
              <a:t>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nd </a:t>
            </a:r>
            <a:r>
              <a:rPr b="0" i="1" lang="zh-CN" sz="18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i="1" lang="zh-CN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to </a:t>
            </a:r>
            <a:r>
              <a:rPr b="0" i="1" lang="zh-CN" sz="18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i="1" lang="zh-CN" sz="1800" spc="-1" strike="noStrike" baseline="-25000">
                <a:solidFill>
                  <a:srgbClr val="000000"/>
                </a:solidFill>
                <a:latin typeface="Arial"/>
              </a:rPr>
              <a:t>M</a:t>
            </a:r>
            <a:r>
              <a:rPr b="0" i="1" lang="zh-CN" sz="1800" spc="-1" strike="noStrike">
                <a:solidFill>
                  <a:srgbClr val="000000"/>
                </a:solidFill>
                <a:latin typeface="Arial"/>
              </a:rPr>
              <a:t>(t)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26" name=""/>
          <p:cNvGraphicFramePr/>
          <p:nvPr/>
        </p:nvGraphicFramePr>
        <p:xfrm>
          <a:off x="4343400" y="7238880"/>
          <a:ext cx="1143000" cy="38124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27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4343400" y="7238880"/>
                    <a:ext cx="1143000" cy="381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/>
          </p:nvPr>
        </p:nvSpPr>
        <p:spPr>
          <a:xfrm>
            <a:off x="151920" y="380880"/>
            <a:ext cx="6363000" cy="778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609480" indent="-609480"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2000" spc="-1" strike="noStrike">
                <a:solidFill>
                  <a:srgbClr val="000000"/>
                </a:solidFill>
                <a:latin typeface="Arial"/>
              </a:rPr>
              <a:t>Reference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990720" indent="0">
              <a:spcBef>
                <a:spcPts val="400"/>
              </a:spcBef>
              <a:buNone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990720" indent="-533520">
              <a:spcBef>
                <a:spcPts val="300"/>
              </a:spcBef>
              <a:buClr>
                <a:srgbClr val="000000"/>
              </a:buClr>
              <a:buFont typeface="Arial"/>
              <a:buAutoNum type="arabi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Sierro N, Makita Y, de Hoon M, Nakai K: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DBTBS: a database of transcriptional regulation in Bacillus subtilis containing upstream intergenic conservation information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Nucleic Acids Res 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2008,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6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(Database issue):D93-96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lvl="1" marL="990720" indent="0">
              <a:spcBef>
                <a:spcPts val="3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lvl="1" marL="990720" indent="-533520">
              <a:spcBef>
                <a:spcPts val="300"/>
              </a:spcBef>
              <a:buClr>
                <a:srgbClr val="000000"/>
              </a:buClr>
              <a:buFont typeface="Arial"/>
              <a:buAutoNum type="arabi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Erill I, Jara M, Salvador N, Escribano M, Campoy S, Barbe J: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Differences in LexA regulon structure among Proteobacteria through in vivo assisted comparative genomics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Nucleic Acids Res 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2004,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32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(22):6617-6626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lvl="1" marL="990720" indent="0">
              <a:spcBef>
                <a:spcPts val="3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lvl="1" marL="990720" indent="-533520">
              <a:spcBef>
                <a:spcPts val="300"/>
              </a:spcBef>
              <a:buClr>
                <a:srgbClr val="000000"/>
              </a:buClr>
              <a:buFont typeface="Arial"/>
              <a:buAutoNum type="arabi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Gama-Castro S, Jimenez-Jacinto V, Peralta-Gil M, Santos-Zavaleta A, Penaloza-Spinola MI, Contreras-Moreira B, Segura-Salazar J, Muniz-Rascado L, Martinez-Flores I, Salgado H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 et al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: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RegulonDB (version 6.0): gene regulation model of Escherichia coli K-12 beyond transcription, active (experimental) annotated promoters and Textpresso navigation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Nucleic Acids Res 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2008,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36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(Database issue):D120-124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lvl="1" marL="990720" indent="0">
              <a:spcBef>
                <a:spcPts val="3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lvl="1" marL="990720" indent="-533520">
              <a:spcBef>
                <a:spcPts val="300"/>
              </a:spcBef>
              <a:buClr>
                <a:srgbClr val="000000"/>
              </a:buClr>
              <a:buFont typeface="Arial"/>
              <a:buAutoNum type="arabi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Mahony S, Benos PV: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STAMP: a web tool for exploring DNA-binding motif similarities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Nucleic Acids Res 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2007,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35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(Web Server issue):W253-258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lvl="1" marL="990720" indent="0">
              <a:spcBef>
                <a:spcPts val="3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lvl="1" marL="990720" indent="-533520">
              <a:spcBef>
                <a:spcPts val="300"/>
              </a:spcBef>
              <a:buClr>
                <a:srgbClr val="000000"/>
              </a:buClr>
              <a:buFont typeface="Arial"/>
              <a:buAutoNum type="arabi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Crooks GE, Hon G, Chandonia JM, Brenner SE: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WebLogo: a sequence logo generator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Genome Res 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2004,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14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(6):1188-1190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lvl="1" marL="990720" indent="0">
              <a:spcBef>
                <a:spcPts val="3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14T20:44:30Z</dcterms:created>
  <dc:creator>sz</dc:creator>
  <dc:description/>
  <dc:language>en-US</dc:language>
  <cp:lastModifiedBy>Shan</cp:lastModifiedBy>
  <dcterms:modified xsi:type="dcterms:W3CDTF">2010-09-29T03:15:25Z</dcterms:modified>
  <cp:revision>127</cp:revision>
  <dc:subject/>
  <dc:title>Slide 1</dc:title>
</cp:coreProperties>
</file>